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7"/>
  </p:notesMasterIdLst>
  <p:sldIdLst>
    <p:sldId id="387" r:id="rId5"/>
    <p:sldId id="396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43940487-C173-6DED-AF85-93F6A0C2C2BA}" name="Ronald Rodriguez" initials="RR" userId="d46245ba6cf3168b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368" autoAdjust="0"/>
    <p:restoredTop sz="96338" autoAdjust="0"/>
  </p:normalViewPr>
  <p:slideViewPr>
    <p:cSldViewPr snapToGrid="0">
      <p:cViewPr varScale="1">
        <p:scale>
          <a:sx n="81" d="100"/>
          <a:sy n="81" d="100"/>
        </p:scale>
        <p:origin x="90" y="2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CE85AE6-0439-456F-BCF6-60B921845DE1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8FFCF8-C588-437B-A32D-4BEEE1BFDC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67349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C9578B-AA67-4EF9-A0B1-6E122A438C8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6520BD2-1CAF-42F1-8918-85CEE0B1DD1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1EFD33-0F6A-4B72-BEB4-A32D7D8B2E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D3F9BF-1A7A-4AA5-9A00-6AB1C53CAA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CEC1DE-5FD0-4C84-953C-E3D43C6873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79695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5E5E4E-A9D2-43ED-9B9A-C241296AA3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069D6DD-C2F9-43DD-8591-F4E5F18F50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8F324B-A686-4838-93D7-6FD251AC00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C3FCDC-2858-46F5-A7E9-E9BDE79B60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0B4BAF-D444-4770-88BF-34FA7A46DA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74528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7D2217C-DB86-4277-99F2-A4041B7C29D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2F2384D-D404-47A2-99C0-F91F8CCD01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0781B2-1DDE-4ACF-9D1F-B9E502BE91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D46A4D-A6FF-4EB5-BD5E-869004778B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CADF04-02B6-41DC-BC41-97D586F516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92063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7C1D6A-CAB5-40D9-AE80-9B862CC5DE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E0C8D0-B404-4A82-B5D5-AB2FFC8AA60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C93BAD-BE77-4B3F-9C9C-7CD463EC07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F17C72-0340-4BDC-B0B4-D3CE6ABDF3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AF8136-22A5-4BAE-A424-512DED2685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0465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361B89-3B8B-4666-9887-6BC4AFF82B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88C43F-715F-4485-ADC4-4C045D21FB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F716C6-721C-4B43-8DFB-97B84EDE9E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0CA836-CE2A-46C8-B010-AA31F56AFD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D0FC0B-50B6-4020-8A2D-5DB054D2C4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7017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0A3AA2-3E78-423D-89BB-71B5B8DF91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F8ED55-7611-4799-81AC-1CE8629397F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A3AB9FA-D807-4ABB-A33A-6350638842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C06BCE4-AD35-41BA-A939-86232EEBAB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1E7235-5F39-4475-A713-920C683AF4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FA16D1-A635-429C-9248-9EA64B3B49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40161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E37716-D3B5-42F7-991B-71BC7E50C8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58D22BB-F132-41CF-B36E-152C095C36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0421EA5-7C57-4D55-A969-68167D78D7E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1BA4A92-AFB7-440C-A43E-9148BC17DE5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B2F270C-8035-4B50-AE9D-83144B782BE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A96D18D-03BE-4887-BBB0-BCAAEEB2D4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5C6A0CC-7F50-428D-AAE2-9DD79A8E8E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8503B97-1F72-4A04-ADA6-36E3499B3F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32469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D1CC94-91F3-42B7-A101-6C2143C63C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1D4368F-8853-4AD3-BF30-AC3BBE9DB1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1ECA4CE-87C9-4E0C-B8C5-6A4FA9E174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82B375C-40BC-4525-B92B-9F40EBE412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3903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45DF131-40A4-4065-B64D-396A85521F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0B191CD-BAF9-424A-9F6B-74323C23E2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6414724-62E6-4A68-B98B-71E577261F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55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B28E29-8C8A-47C3-A687-1EBCDBA63E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0CBE6D-3C41-4731-A7D5-75FD1E8FE7D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F7751D9-B22D-4539-9879-3EC6933EC0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4555650-F692-410F-B00C-C340780AE9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2C43FFD-B963-482F-B3BB-78324A195A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52A100E-2BA2-44DE-9490-E304BB1B94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2840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345E46-FB78-4CE3-9D75-A0FEF73114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7F0F3D6-C0AF-489F-9297-C30CA8EF66B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920BD96-27BF-4803-ACBC-05A1E75F31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E64186C-52B5-4F9B-8F71-5C416C245B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0FDE7E-351F-4B90-9C24-782EDB2EFA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E22367A-F8DE-4CA2-B00E-3A5E00EA78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37148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59A091F-9661-4364-B04B-B914ABFE97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3C6618-FD82-49BD-B945-CA8E0CC8BD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EEB97E-39CB-467B-BF23-70D2784F183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0C53AC-0B3A-4181-899B-2E855ABC97A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04A5BB-2E07-4956-AD29-B1C6C40AE2B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15703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E285803-2E16-48AF-B424-75613F990E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90593" y="907336"/>
            <a:ext cx="7459146" cy="56470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830717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164874E-B7A4-A605-C683-544311CE0F8D}"/>
              </a:ext>
            </a:extLst>
          </p:cNvPr>
          <p:cNvSpPr txBox="1"/>
          <p:nvPr/>
        </p:nvSpPr>
        <p:spPr>
          <a:xfrm>
            <a:off x="377041" y="223376"/>
            <a:ext cx="11450781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S2.  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earson correlation coefficient values and 95% confidence interval for the drug-only group (top) and virus-infected + drug (bottom)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nder the various tested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reatment conditions. 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e combination of VPA and DHA, in the pre-incubated experiment showed most profound change with the Pearson correlation coefficient of  -0.7</a:t>
            </a:r>
          </a:p>
        </p:txBody>
      </p:sp>
    </p:spTree>
    <p:extLst>
      <p:ext uri="{BB962C8B-B14F-4D97-AF65-F5344CB8AC3E}">
        <p14:creationId xmlns:p14="http://schemas.microsoft.com/office/powerpoint/2010/main" val="35576380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D7E7BFB616F1640AF8C785F8C3121EC" ma:contentTypeVersion="3" ma:contentTypeDescription="Create a new document." ma:contentTypeScope="" ma:versionID="7d684ee0481be49b70e9daf802370bba">
  <xsd:schema xmlns:xsd="http://www.w3.org/2001/XMLSchema" xmlns:xs="http://www.w3.org/2001/XMLSchema" xmlns:p="http://schemas.microsoft.com/office/2006/metadata/properties" xmlns:ns2="359f2c7a-23e1-4954-80fd-c0b3c38bf32a" targetNamespace="http://schemas.microsoft.com/office/2006/metadata/properties" ma:root="true" ma:fieldsID="7498b748389c12a3e0d90ff5256f0a9c" ns2:_="">
    <xsd:import namespace="359f2c7a-23e1-4954-80fd-c0b3c38bf32a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59f2c7a-23e1-4954-80fd-c0b3c38bf32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AD81880F-5CD8-4F88-9C38-34D55566764D}"/>
</file>

<file path=customXml/itemProps2.xml><?xml version="1.0" encoding="utf-8"?>
<ds:datastoreItem xmlns:ds="http://schemas.openxmlformats.org/officeDocument/2006/customXml" ds:itemID="{32F365F7-0250-4F23-86EC-6E8B7A8F3600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C90C87FD-24A2-4011-A456-B98DFEB1442D}">
  <ds:schemaRefs>
    <ds:schemaRef ds:uri="http://purl.org/dc/terms/"/>
    <ds:schemaRef ds:uri="http://schemas.microsoft.com/office/2006/documentManagement/types"/>
    <ds:schemaRef ds:uri="http://purl.org/dc/dcmitype/"/>
    <ds:schemaRef ds:uri="http://schemas.microsoft.com/office/2006/metadata/properties"/>
    <ds:schemaRef ds:uri="http://schemas.microsoft.com/office/infopath/2007/PartnerControls"/>
    <ds:schemaRef ds:uri="http://purl.org/dc/elements/1.1/"/>
    <ds:schemaRef ds:uri="http://schemas.openxmlformats.org/package/2006/metadata/core-properties"/>
    <ds:schemaRef ds:uri="359f2c7a-23e1-4954-80fd-c0b3c38bf32a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6408</TotalTime>
  <Words>56</Words>
  <Application>Microsoft Office PowerPoint</Application>
  <PresentationFormat>Widescreen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nald Rodriguez</dc:creator>
  <cp:lastModifiedBy>Ronald Rodriguez</cp:lastModifiedBy>
  <cp:revision>40</cp:revision>
  <dcterms:created xsi:type="dcterms:W3CDTF">2023-01-03T19:51:06Z</dcterms:created>
  <dcterms:modified xsi:type="dcterms:W3CDTF">2023-09-01T15:36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D7E7BFB616F1640AF8C785F8C3121EC</vt:lpwstr>
  </property>
</Properties>
</file>